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8" t="13280" r="2623" b="13980"/>
          <a:stretch/>
        </p:blipFill>
        <p:spPr bwMode="auto">
          <a:xfrm>
            <a:off x="952182" y="0"/>
            <a:ext cx="6401435" cy="355409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33400" y="3810000"/>
            <a:ext cx="7239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Intranasal vaccination with WIV combined with mucosal adjuvants induces cross-reactive local Ig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weeks after the 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ccination, animals (n=6/group) were sacrificed and nasal and lung washes were collected. IgA titers in nose washes (A-C) and lung washes (D-F) were determined using PR8 WIV (A, D), (H1N1)pdm09 WIV (B, E) or  X-31 WIV (C, F) as coating antigen. Groups: 1: PBS, 2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3: WIV+CAF0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4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5: WIV+ CAF09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6: WIV+ CTA1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7: WIV+ CTA1-3Me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. Dashed lines indicat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gA titers are represented as 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ters with level of significance as *p&lt;.05 and **p&lt;.01 calculated using Mann-Whitney U-test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2769813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.C. Bhide</dc:creator>
  <cp:lastModifiedBy>Y.C. Bhide</cp:lastModifiedBy>
  <cp:revision>2</cp:revision>
  <dcterms:created xsi:type="dcterms:W3CDTF">2006-08-16T00:00:00Z</dcterms:created>
  <dcterms:modified xsi:type="dcterms:W3CDTF">2018-09-27T11:58:14Z</dcterms:modified>
</cp:coreProperties>
</file>